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8" d="100"/>
          <a:sy n="88" d="100"/>
        </p:scale>
        <p:origin x="49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936A2-4E84-441B-B125-FEE0DAEDDE5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FF802-CC4F-42F3-AFC2-FB575C7A9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8362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936A2-4E84-441B-B125-FEE0DAEDDE5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FF802-CC4F-42F3-AFC2-FB575C7A9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13926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936A2-4E84-441B-B125-FEE0DAEDDE5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FF802-CC4F-42F3-AFC2-FB575C7A9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48141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936A2-4E84-441B-B125-FEE0DAEDDE5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FF802-CC4F-42F3-AFC2-FB575C7A9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64147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936A2-4E84-441B-B125-FEE0DAEDDE5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FF802-CC4F-42F3-AFC2-FB575C7A9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02145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936A2-4E84-441B-B125-FEE0DAEDDE5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FF802-CC4F-42F3-AFC2-FB575C7A9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40238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936A2-4E84-441B-B125-FEE0DAEDDE5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FF802-CC4F-42F3-AFC2-FB575C7A9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88773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936A2-4E84-441B-B125-FEE0DAEDDE5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FF802-CC4F-42F3-AFC2-FB575C7A9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88948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936A2-4E84-441B-B125-FEE0DAEDDE5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FF802-CC4F-42F3-AFC2-FB575C7A9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44901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936A2-4E84-441B-B125-FEE0DAEDDE5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FF802-CC4F-42F3-AFC2-FB575C7A9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75320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8936A2-4E84-441B-B125-FEE0DAEDDE5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CFF802-CC4F-42F3-AFC2-FB575C7A9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75738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8936A2-4E84-441B-B125-FEE0DAEDDE5F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CFF802-CC4F-42F3-AFC2-FB575C7A99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87463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97280" y="644435"/>
            <a:ext cx="9257211" cy="5290457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Rectangle 1"/>
          <p:cNvSpPr>
            <a:spLocks noChangeArrowheads="1"/>
          </p:cNvSpPr>
          <p:nvPr/>
        </p:nvSpPr>
        <p:spPr bwMode="auto">
          <a:xfrm>
            <a:off x="653143" y="595562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igure S5.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Correlation between β-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atin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inhibition activity (BIHA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, µM) and 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­, µM) for deprotected chloroquinolines against sensitive strain 3D7.</a:t>
            </a: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144838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9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c Nguyen</dc:creator>
  <cp:lastModifiedBy>Ngoc Nguyen</cp:lastModifiedBy>
  <cp:revision>2</cp:revision>
  <dcterms:created xsi:type="dcterms:W3CDTF">2020-07-03T15:57:01Z</dcterms:created>
  <dcterms:modified xsi:type="dcterms:W3CDTF">2020-08-04T16:31:20Z</dcterms:modified>
</cp:coreProperties>
</file>